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84BB6-2CF7-4ADF-B6F7-F975A9C9E3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1B5DF-CFBE-4A8B-9B3D-06937B13CC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D6DF3-1439-4371-9196-6C64C22DE4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AAAC97-9268-45BB-BA0F-06203F655F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818874-158D-4DB8-868B-96C3060ADC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21A44-2702-40DA-B459-8875A4ACAA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E68BA2-FCBD-4A13-84F8-DBFBACFE4E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E9DEF-1F01-4B0C-8FD4-04A11A55C1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16AE08-3777-40D5-BC9E-630F86B291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9E8BE-501E-4C0F-AEF6-9593286236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25E71-D3DB-44E9-9079-E6EFA50C0C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FDE0BC-D038-4CB7-9E69-77AD2FAAA2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4C2718-93B5-4B0F-8F8C-F0A1346FF88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33520" y="990720"/>
            <a:ext cx="5257800" cy="5657760"/>
            <a:chOff x="533520" y="990720"/>
            <a:chExt cx="5257800" cy="5657760"/>
          </a:xfrm>
        </p:grpSpPr>
        <p:sp>
          <p:nvSpPr>
            <p:cNvPr id="42" name=""/>
            <p:cNvSpPr/>
            <p:nvPr/>
          </p:nvSpPr>
          <p:spPr>
            <a:xfrm>
              <a:off x="2487240" y="5447520"/>
              <a:ext cx="609840" cy="94644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flipH="1">
              <a:off x="3148560" y="5447520"/>
              <a:ext cx="597240" cy="93384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 flipV="1">
              <a:off x="3272760" y="5323320"/>
              <a:ext cx="0" cy="4086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"/>
            <p:cNvGrpSpPr/>
            <p:nvPr/>
          </p:nvGrpSpPr>
          <p:grpSpPr>
            <a:xfrm>
              <a:off x="533520" y="990720"/>
              <a:ext cx="5257800" cy="4306320"/>
              <a:chOff x="533520" y="990720"/>
              <a:chExt cx="5257800" cy="4306320"/>
            </a:xfrm>
          </p:grpSpPr>
          <p:grpSp>
            <p:nvGrpSpPr>
              <p:cNvPr id="46" name=""/>
              <p:cNvGrpSpPr/>
              <p:nvPr/>
            </p:nvGrpSpPr>
            <p:grpSpPr>
              <a:xfrm>
                <a:off x="533520" y="990720"/>
                <a:ext cx="5257800" cy="3450960"/>
                <a:chOff x="533520" y="990720"/>
                <a:chExt cx="5257800" cy="3450960"/>
              </a:xfrm>
            </p:grpSpPr>
            <p:pic>
              <p:nvPicPr>
                <p:cNvPr id="47" name="" descr=""/>
                <p:cNvPicPr/>
                <p:nvPr/>
              </p:nvPicPr>
              <p:blipFill>
                <a:blip r:embed="rId1"/>
                <a:srcRect l="0" t="-5322" r="0" b="57157"/>
                <a:stretch/>
              </p:blipFill>
              <p:spPr>
                <a:xfrm>
                  <a:off x="533520" y="990720"/>
                  <a:ext cx="5257800" cy="33778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8" name=""/>
                <p:cNvSpPr/>
                <p:nvPr/>
              </p:nvSpPr>
              <p:spPr>
                <a:xfrm>
                  <a:off x="736560" y="3967920"/>
                  <a:ext cx="609120" cy="473760"/>
                </a:xfrm>
                <a:prstGeom prst="ellipse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9" name=""/>
              <p:cNvSpPr/>
              <p:nvPr/>
            </p:nvSpPr>
            <p:spPr>
              <a:xfrm flipH="1">
                <a:off x="1691280" y="3240720"/>
                <a:ext cx="1142280" cy="205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3051720" y="3189960"/>
                <a:ext cx="1551240" cy="210132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1" name=""/>
            <p:cNvSpPr/>
            <p:nvPr/>
          </p:nvSpPr>
          <p:spPr>
            <a:xfrm>
              <a:off x="1714320" y="5322960"/>
              <a:ext cx="2914560" cy="36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714320" y="5369040"/>
              <a:ext cx="2914560" cy="36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980800" y="5258160"/>
              <a:ext cx="272160" cy="155160"/>
            </a:xfrm>
            <a:prstGeom prst="rect">
              <a:avLst/>
            </a:prstGeom>
            <a:solidFill>
              <a:srgbClr val="ff66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110680" y="5232240"/>
              <a:ext cx="836640" cy="214200"/>
            </a:xfrm>
            <a:prstGeom prst="leftArrow">
              <a:avLst>
                <a:gd name="adj1" fmla="val 50000"/>
                <a:gd name="adj2" fmla="val 97647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81360" rIns="81360" tIns="40680" bIns="406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rot="10800000">
              <a:off x="3285720" y="5231880"/>
              <a:ext cx="928080" cy="227160"/>
            </a:xfrm>
            <a:prstGeom prst="leftArrow">
              <a:avLst>
                <a:gd name="adj1" fmla="val 50000"/>
                <a:gd name="adj2" fmla="val 102139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2110680" y="4959360"/>
              <a:ext cx="0" cy="4086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2967120" y="4959360"/>
              <a:ext cx="0" cy="4086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4213800" y="4953240"/>
              <a:ext cx="0" cy="4017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720880" y="4745880"/>
              <a:ext cx="47376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1360" rIns="81360" tIns="40680" bIns="4068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Spe</a:t>
              </a:r>
              <a:r>
                <a:rPr b="1" lang="en-US" sz="12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896120" y="4739400"/>
              <a:ext cx="467280" cy="266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1360" rIns="81360" tIns="40680" bIns="4068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Sac</a:t>
              </a:r>
              <a:r>
                <a:rPr b="1" lang="en-US" sz="12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959200" y="5628960"/>
              <a:ext cx="67104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1360" rIns="81360" tIns="40680" bIns="4068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Kpn</a:t>
              </a:r>
              <a:r>
                <a:rPr b="1" lang="en-US" sz="12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768840" y="4739400"/>
              <a:ext cx="871560" cy="266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1360" rIns="81360" tIns="40680" bIns="4068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Bam</a:t>
              </a:r>
              <a:r>
                <a:rPr b="1" lang="en-US" sz="12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H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943280" y="6350040"/>
              <a:ext cx="2400120" cy="29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1360" rIns="81360" tIns="40680" bIns="4068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OsCYP96B4 </a:t>
              </a:r>
              <a:r>
                <a:rPr b="1" lang="en-US" sz="1400" spc="-1" strike="noStrike">
                  <a:solidFill>
                    <a:srgbClr val="800000"/>
                  </a:solidFill>
                  <a:latin typeface="Times New Roman"/>
                  <a:ea typeface="SimSun"/>
                </a:rPr>
                <a:t>5’UTR Reg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"/>
          <p:cNvSpPr/>
          <p:nvPr/>
        </p:nvSpPr>
        <p:spPr>
          <a:xfrm>
            <a:off x="609480" y="990720"/>
            <a:ext cx="213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orting Figure S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914400" y="7162920"/>
            <a:ext cx="5181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orting Figure S6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onstruct used for double-stranded RNAi analyses. The backbone construct pTCK303 is a gift from Prof. Kang Chong [46]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4T08:18:26Z</dcterms:created>
  <dc:creator>shuye</dc:creator>
  <dc:description/>
  <dc:language>en-US</dc:language>
  <cp:lastModifiedBy>shuye</cp:lastModifiedBy>
  <dcterms:modified xsi:type="dcterms:W3CDTF">2011-08-16T07:38:54Z</dcterms:modified>
  <cp:revision>9</cp:revision>
  <dc:subject/>
  <dc:title>Slide 1</dc:title>
</cp:coreProperties>
</file>